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6" r:id="rId3"/>
    <p:sldId id="267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912352A-F8F2-4241-A57A-0FB2BB3DB0BC}" v="2" dt="2020-12-01T12:03:22.674"/>
    <p1510:client id="{72ABA8CF-AAC3-A098-C699-150C0EE7C0B6}" v="3" dt="2021-02-17T12:00:41.161"/>
    <p1510:client id="{D3CE2B6E-A28C-1B32-27F4-85126501BE24}" v="97" dt="2020-12-03T15:28:01.98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guel Burgos Lozano" userId="35b2351a92a5e1ea" providerId="LiveId" clId="{6912352A-F8F2-4241-A57A-0FB2BB3DB0BC}"/>
    <pc:docChg chg="undo custSel addSld delSld modSld">
      <pc:chgData name="Miguel Burgos Lozano" userId="35b2351a92a5e1ea" providerId="LiveId" clId="{6912352A-F8F2-4241-A57A-0FB2BB3DB0BC}" dt="2020-12-01T12:03:22.674" v="7"/>
      <pc:docMkLst>
        <pc:docMk/>
      </pc:docMkLst>
      <pc:sldChg chg="modSp mod">
        <pc:chgData name="Miguel Burgos Lozano" userId="35b2351a92a5e1ea" providerId="LiveId" clId="{6912352A-F8F2-4241-A57A-0FB2BB3DB0BC}" dt="2020-12-01T12:03:22.674" v="7"/>
        <pc:sldMkLst>
          <pc:docMk/>
          <pc:sldMk cId="3010419371" sldId="266"/>
        </pc:sldMkLst>
        <pc:graphicFrameChg chg="mod modGraphic">
          <ac:chgData name="Miguel Burgos Lozano" userId="35b2351a92a5e1ea" providerId="LiveId" clId="{6912352A-F8F2-4241-A57A-0FB2BB3DB0BC}" dt="2020-12-01T12:03:22.674" v="7"/>
          <ac:graphicFrameMkLst>
            <pc:docMk/>
            <pc:sldMk cId="3010419371" sldId="266"/>
            <ac:graphicFrameMk id="4" creationId="{3978613C-BBD5-4885-9B71-860CA3454F77}"/>
          </ac:graphicFrameMkLst>
        </pc:graphicFrameChg>
      </pc:sldChg>
      <pc:sldChg chg="new del">
        <pc:chgData name="Miguel Burgos Lozano" userId="35b2351a92a5e1ea" providerId="LiveId" clId="{6912352A-F8F2-4241-A57A-0FB2BB3DB0BC}" dt="2020-12-01T12:00:56.299" v="1" actId="680"/>
        <pc:sldMkLst>
          <pc:docMk/>
          <pc:sldMk cId="3090339948" sldId="268"/>
        </pc:sldMkLst>
      </pc:sldChg>
    </pc:docChg>
  </pc:docChgLst>
  <pc:docChgLst>
    <pc:chgData name="MARÍA DEL MAR NOBLEJAS LÓPEZ" userId="S::mariadelmar.noblejas@uclm.es::e5acd636-944d-4a5c-a36c-21caa066a2b6" providerId="AD" clId="Web-{72ABA8CF-AAC3-A098-C699-150C0EE7C0B6}"/>
    <pc:docChg chg="modSld">
      <pc:chgData name="MARÍA DEL MAR NOBLEJAS LÓPEZ" userId="S::mariadelmar.noblejas@uclm.es::e5acd636-944d-4a5c-a36c-21caa066a2b6" providerId="AD" clId="Web-{72ABA8CF-AAC3-A098-C699-150C0EE7C0B6}" dt="2021-02-17T12:00:40.505" v="0" actId="20577"/>
      <pc:docMkLst>
        <pc:docMk/>
      </pc:docMkLst>
      <pc:sldChg chg="modSp">
        <pc:chgData name="MARÍA DEL MAR NOBLEJAS LÓPEZ" userId="S::mariadelmar.noblejas@uclm.es::e5acd636-944d-4a5c-a36c-21caa066a2b6" providerId="AD" clId="Web-{72ABA8CF-AAC3-A098-C699-150C0EE7C0B6}" dt="2021-02-17T12:00:40.505" v="0" actId="20577"/>
        <pc:sldMkLst>
          <pc:docMk/>
          <pc:sldMk cId="33740680" sldId="267"/>
        </pc:sldMkLst>
        <pc:spChg chg="mod">
          <ac:chgData name="MARÍA DEL MAR NOBLEJAS LÓPEZ" userId="S::mariadelmar.noblejas@uclm.es::e5acd636-944d-4a5c-a36c-21caa066a2b6" providerId="AD" clId="Web-{72ABA8CF-AAC3-A098-C699-150C0EE7C0B6}" dt="2021-02-17T12:00:40.505" v="0" actId="20577"/>
          <ac:spMkLst>
            <pc:docMk/>
            <pc:sldMk cId="33740680" sldId="267"/>
            <ac:spMk id="7" creationId="{4FA2C513-BCA5-4EA1-BD67-579228D87EF4}"/>
          </ac:spMkLst>
        </pc:spChg>
      </pc:sldChg>
    </pc:docChg>
  </pc:docChgLst>
  <pc:docChgLst>
    <pc:chgData name="cristina.nieto@usal.es" userId="S::cristina.nieto_usal.es#ext#@pruebasaluuclm.onmicrosoft.com::6ef41bd3-103b-4a41-a0ea-234385fc9317" providerId="AD" clId="Web-{D3CE2B6E-A28C-1B32-27F4-85126501BE24}"/>
    <pc:docChg chg="modSld">
      <pc:chgData name="cristina.nieto@usal.es" userId="S::cristina.nieto_usal.es#ext#@pruebasaluuclm.onmicrosoft.com::6ef41bd3-103b-4a41-a0ea-234385fc9317" providerId="AD" clId="Web-{D3CE2B6E-A28C-1B32-27F4-85126501BE24}" dt="2020-12-03T15:27:46.824" v="87"/>
      <pc:docMkLst>
        <pc:docMk/>
      </pc:docMkLst>
      <pc:sldChg chg="modSp">
        <pc:chgData name="cristina.nieto@usal.es" userId="S::cristina.nieto_usal.es#ext#@pruebasaluuclm.onmicrosoft.com::6ef41bd3-103b-4a41-a0ea-234385fc9317" providerId="AD" clId="Web-{D3CE2B6E-A28C-1B32-27F4-85126501BE24}" dt="2020-12-03T15:27:46.824" v="87"/>
        <pc:sldMkLst>
          <pc:docMk/>
          <pc:sldMk cId="2476697298" sldId="264"/>
        </pc:sldMkLst>
        <pc:graphicFrameChg chg="mod modGraphic">
          <ac:chgData name="cristina.nieto@usal.es" userId="S::cristina.nieto_usal.es#ext#@pruebasaluuclm.onmicrosoft.com::6ef41bd3-103b-4a41-a0ea-234385fc9317" providerId="AD" clId="Web-{D3CE2B6E-A28C-1B32-27F4-85126501BE24}" dt="2020-12-03T15:27:46.824" v="87"/>
          <ac:graphicFrameMkLst>
            <pc:docMk/>
            <pc:sldMk cId="2476697298" sldId="264"/>
            <ac:graphicFrameMk id="5" creationId="{EC26F067-2DD1-4E42-B971-1399FA6B7309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17/0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EC26F067-2DD1-4E42-B971-1399FA6B73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654191"/>
              </p:ext>
            </p:extLst>
          </p:nvPr>
        </p:nvGraphicFramePr>
        <p:xfrm>
          <a:off x="1655676" y="980728"/>
          <a:ext cx="5832648" cy="461375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322067">
                  <a:extLst>
                    <a:ext uri="{9D8B030D-6E8A-4147-A177-3AD203B41FA5}">
                      <a16:colId xmlns:a16="http://schemas.microsoft.com/office/drawing/2014/main" val="3347701079"/>
                    </a:ext>
                  </a:extLst>
                </a:gridCol>
                <a:gridCol w="1322067">
                  <a:extLst>
                    <a:ext uri="{9D8B030D-6E8A-4147-A177-3AD203B41FA5}">
                      <a16:colId xmlns:a16="http://schemas.microsoft.com/office/drawing/2014/main" val="595657366"/>
                    </a:ext>
                  </a:extLst>
                </a:gridCol>
                <a:gridCol w="3188514">
                  <a:extLst>
                    <a:ext uri="{9D8B030D-6E8A-4147-A177-3AD203B41FA5}">
                      <a16:colId xmlns:a16="http://schemas.microsoft.com/office/drawing/2014/main" val="464863085"/>
                    </a:ext>
                  </a:extLst>
                </a:gridCol>
              </a:tblGrid>
              <a:tr h="26348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ntibody</a:t>
                      </a:r>
                      <a:endParaRPr lang="es-ES" sz="1000" b="0" dirty="0">
                        <a:effectLst/>
                        <a:latin typeface="Helvetica" panose="020B0604020202020204" pitchFamily="34" charset="0"/>
                        <a:ea typeface="Calibri" panose="020F0502020204030204" pitchFamily="34" charset="0"/>
                        <a:cs typeface="Helvetica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</a:rPr>
                        <a:t>Reference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 err="1">
                          <a:effectLst/>
                        </a:rPr>
                        <a:t>Obtained</a:t>
                      </a:r>
                      <a:r>
                        <a:rPr lang="es-ES" sz="1100" b="0" dirty="0">
                          <a:effectLst/>
                        </a:rPr>
                        <a:t> </a:t>
                      </a:r>
                      <a:r>
                        <a:rPr lang="es-ES" sz="1100" b="0" dirty="0" err="1">
                          <a:effectLst/>
                        </a:rPr>
                        <a:t>by</a:t>
                      </a:r>
                      <a:r>
                        <a:rPr lang="es-ES" sz="1100" b="0" dirty="0">
                          <a:effectLst/>
                        </a:rPr>
                        <a:t>: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31038448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NA</a:t>
                      </a:r>
                      <a:r>
                        <a:rPr lang="es-ES" sz="1000" b="0" baseline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Pol II</a:t>
                      </a:r>
                      <a:endParaRPr lang="es-ES" sz="1000" b="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5676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200" dirty="0">
                          <a:solidFill>
                            <a:schemeClr val="tx1"/>
                          </a:solidFill>
                          <a:effectLst/>
                        </a:rPr>
                        <a:t>Santa Cruz Biotechnology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74894538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hospho</a:t>
                      </a:r>
                      <a:r>
                        <a:rPr lang="es-ES" sz="1000" b="0" baseline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RNA Pol II pRpb1 CTD (Ser 215)</a:t>
                      </a:r>
                      <a:endParaRPr lang="es-ES" sz="1000" b="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473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Cell Signaling Technologies, Beverly, MA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98410271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AR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954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Cell Signaling Technologies, Beverly, MA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10148187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CL-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78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tx1"/>
                          </a:solidFill>
                          <a:effectLst/>
                        </a:rPr>
                        <a:t>Santa Cruz Biotechnology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06280870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CL-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81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tx1"/>
                          </a:solidFill>
                          <a:effectLst/>
                        </a:rPr>
                        <a:t>Santa Cruz Biotechnology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15654281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IAP-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653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 panose="020F0502020204030204" pitchFamily="34" charset="0"/>
                          <a:cs typeface="Times New Roman"/>
                        </a:rPr>
                        <a:t>BD </a:t>
                      </a:r>
                      <a:r>
                        <a:rPr lang="es-ES" sz="1100" b="0" dirty="0" err="1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 panose="020F0502020204030204" pitchFamily="34" charset="0"/>
                          <a:cs typeface="Times New Roman"/>
                        </a:rPr>
                        <a:t>Biosciences</a:t>
                      </a:r>
                      <a:endParaRPr lang="es-ES" sz="1100" b="0" dirty="0" err="1">
                        <a:solidFill>
                          <a:schemeClr val="tx1"/>
                        </a:solidFill>
                        <a:effectLst/>
                        <a:latin typeface="Calibri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52098456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CL-X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021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>
                        <a:lnSpc>
                          <a:spcPct val="114999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s-ES" sz="1100" b="0" i="0" u="none" strike="noStrike" noProof="0" dirty="0">
                          <a:effectLst/>
                        </a:rPr>
                        <a:t>BD </a:t>
                      </a:r>
                      <a:r>
                        <a:rPr lang="es-ES" sz="1100" b="0" i="0" u="none" strike="noStrike" noProof="0" dirty="0" err="1">
                          <a:effectLst/>
                        </a:rPr>
                        <a:t>Biosciences</a:t>
                      </a:r>
                      <a:endParaRPr lang="es-ES" dirty="0" err="1"/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18033335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XIA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071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>
                        <a:lnSpc>
                          <a:spcPct val="114999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US" sz="1100" b="0" i="0" u="none" strike="noStrike" noProof="0" dirty="0">
                          <a:effectLst/>
                          <a:latin typeface="Calibri"/>
                        </a:rPr>
                        <a:t>BD Biosciences</a:t>
                      </a:r>
                      <a:endParaRPr lang="es-ES" dirty="0"/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195576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/>
                          <a:cs typeface="Helvetica"/>
                        </a:rPr>
                        <a:t>Gamma H2AX</a:t>
                      </a:r>
                      <a:endParaRPr lang="es-ES" sz="1000" b="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257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Cell Signaling Technologies, Beverly, MA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97270477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AD5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834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</a:t>
                      </a:r>
                      <a:r>
                        <a:rPr lang="es-ES" sz="1100" b="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technology</a:t>
                      </a: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US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89922229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/>
                      <a:r>
                        <a:rPr lang="es-ES" sz="10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AD5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2015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0" dirty="0">
                          <a:effectLst/>
                          <a:latin typeface="Calibri"/>
                          <a:ea typeface="Calibri" panose="020F0502020204030204" pitchFamily="34" charset="0"/>
                          <a:cs typeface="Times New Roman"/>
                        </a:rPr>
                        <a:t>Santa Cruz </a:t>
                      </a:r>
                      <a:r>
                        <a:rPr lang="es-ES" sz="1100" b="0" dirty="0" err="1">
                          <a:effectLst/>
                          <a:latin typeface="Calibri"/>
                          <a:ea typeface="Calibri" panose="020F0502020204030204" pitchFamily="34" charset="0"/>
                          <a:cs typeface="Times New Roman"/>
                        </a:rPr>
                        <a:t>Biotechnology</a:t>
                      </a:r>
                      <a:r>
                        <a:rPr lang="es-ES" sz="1100" b="0" dirty="0">
                          <a:effectLst/>
                          <a:latin typeface="Calibri"/>
                          <a:ea typeface="Calibri" panose="020F0502020204030204" pitchFamily="34" charset="0"/>
                          <a:cs typeface="Times New Roman"/>
                        </a:rPr>
                        <a:t>, US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92782882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00" b="0" dirty="0" err="1">
                          <a:effectLst/>
                          <a:latin typeface="Helvetica"/>
                          <a:ea typeface="Calibri" panose="020F0502020204030204" pitchFamily="34" charset="0"/>
                          <a:cs typeface="Helvetica"/>
                        </a:rPr>
                        <a:t>Calnexin</a:t>
                      </a:r>
                      <a:endParaRPr lang="es-ES" sz="1000" b="0" dirty="0" err="1">
                        <a:effectLst/>
                        <a:latin typeface="Helvetica" panose="020B0604020202020204" pitchFamily="34" charset="0"/>
                        <a:ea typeface="Calibri" panose="020F0502020204030204" pitchFamily="34" charset="0"/>
                        <a:cs typeface="Helvetica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4666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</a:rPr>
                        <a:t>Santa Cruz </a:t>
                      </a:r>
                      <a:r>
                        <a:rPr lang="es-ES" sz="1100" b="0" dirty="0" err="1">
                          <a:solidFill>
                            <a:schemeClr val="tx1"/>
                          </a:solidFill>
                          <a:effectLst/>
                        </a:rPr>
                        <a:t>Biotechnology</a:t>
                      </a: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</a:rPr>
                        <a:t>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65217118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00" b="0" dirty="0">
                          <a:effectLst/>
                          <a:latin typeface="Helvetica" panose="020B0604020202020204" pitchFamily="34" charset="0"/>
                          <a:ea typeface="Calibri" panose="020F0502020204030204" pitchFamily="34" charset="0"/>
                          <a:cs typeface="Helvetica" panose="020B0604020202020204" pitchFamily="34" charset="0"/>
                        </a:rPr>
                        <a:t>BRD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344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Cell Signaling Technologies, Beverly, MA, USA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23852458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00" b="0" dirty="0">
                          <a:effectLst/>
                          <a:latin typeface="Helvetica" panose="020B0604020202020204" pitchFamily="34" charset="0"/>
                          <a:ea typeface="Calibri" panose="020F0502020204030204" pitchFamily="34" charset="0"/>
                          <a:cs typeface="Helvetica" panose="020B0604020202020204" pitchFamily="34" charset="0"/>
                        </a:rPr>
                        <a:t>ERBB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P1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lbiochem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51349998"/>
                  </a:ext>
                </a:extLst>
              </a:tr>
              <a:tr h="27807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50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-Tyr 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702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</a:t>
                      </a:r>
                      <a:r>
                        <a:rPr lang="es-ES" sz="11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technology</a:t>
                      </a:r>
                      <a:r>
                        <a:rPr lang="es-E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USA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4227784244"/>
                  </a:ext>
                </a:extLst>
              </a:tr>
            </a:tbl>
          </a:graphicData>
        </a:graphic>
      </p:graphicFrame>
      <p:sp>
        <p:nvSpPr>
          <p:cNvPr id="7" name="2 Subtítulo">
            <a:extLst>
              <a:ext uri="{FF2B5EF4-FFF2-40B4-BE49-F238E27FC236}">
                <a16:creationId xmlns:a16="http://schemas.microsoft.com/office/drawing/2014/main" id="{6ED4C4FE-2CDF-44BD-9621-C14D87630904}"/>
              </a:ext>
            </a:extLst>
          </p:cNvPr>
          <p:cNvSpPr txBox="1">
            <a:spLocks/>
          </p:cNvSpPr>
          <p:nvPr/>
        </p:nvSpPr>
        <p:spPr>
          <a:xfrm>
            <a:off x="1259632" y="5877272"/>
            <a:ext cx="6400800" cy="6480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dirty="0" err="1"/>
              <a:t>Supp</a:t>
            </a:r>
            <a:r>
              <a:rPr lang="es-ES" dirty="0"/>
              <a:t>. Table 1</a:t>
            </a:r>
          </a:p>
        </p:txBody>
      </p:sp>
    </p:spTree>
    <p:extLst>
      <p:ext uri="{BB962C8B-B14F-4D97-AF65-F5344CB8AC3E}">
        <p14:creationId xmlns:p14="http://schemas.microsoft.com/office/powerpoint/2010/main" val="24766972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2 Subtítulo">
            <a:extLst>
              <a:ext uri="{FF2B5EF4-FFF2-40B4-BE49-F238E27FC236}">
                <a16:creationId xmlns:a16="http://schemas.microsoft.com/office/drawing/2014/main" id="{4FA2C513-BCA5-4EA1-BD67-579228D87EF4}"/>
              </a:ext>
            </a:extLst>
          </p:cNvPr>
          <p:cNvSpPr txBox="1">
            <a:spLocks/>
          </p:cNvSpPr>
          <p:nvPr/>
        </p:nvSpPr>
        <p:spPr>
          <a:xfrm>
            <a:off x="1259632" y="5877272"/>
            <a:ext cx="6400800" cy="6480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dirty="0" err="1"/>
              <a:t>Supp</a:t>
            </a:r>
            <a:r>
              <a:rPr lang="es-ES" dirty="0"/>
              <a:t>. Table 2</a:t>
            </a:r>
          </a:p>
        </p:txBody>
      </p:sp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3978613C-BBD5-4885-9B71-860CA3454F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7683584"/>
              </p:ext>
            </p:extLst>
          </p:nvPr>
        </p:nvGraphicFramePr>
        <p:xfrm>
          <a:off x="1979712" y="1916832"/>
          <a:ext cx="5393690" cy="108889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861695">
                  <a:extLst>
                    <a:ext uri="{9D8B030D-6E8A-4147-A177-3AD203B41FA5}">
                      <a16:colId xmlns:a16="http://schemas.microsoft.com/office/drawing/2014/main" val="3347701079"/>
                    </a:ext>
                  </a:extLst>
                </a:gridCol>
                <a:gridCol w="2214880">
                  <a:extLst>
                    <a:ext uri="{9D8B030D-6E8A-4147-A177-3AD203B41FA5}">
                      <a16:colId xmlns:a16="http://schemas.microsoft.com/office/drawing/2014/main" val="595657366"/>
                    </a:ext>
                  </a:extLst>
                </a:gridCol>
                <a:gridCol w="2317115">
                  <a:extLst>
                    <a:ext uri="{9D8B030D-6E8A-4147-A177-3AD203B41FA5}">
                      <a16:colId xmlns:a16="http://schemas.microsoft.com/office/drawing/2014/main" val="46486308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Gen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Forward prime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Reverse prime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310384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GGATGAGGTGGAACGTG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TTCAGTCGCTCCAGGTCT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85377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HOXB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CTCAGGAACTGACCGCAAA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GCCGGTTCTGAAACCAAAT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48945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MEIS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CGATGATGCAACCTCAACC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ATCCGGATCATCATCGT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984102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TCERG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GCCCGTTCAGAACAAAC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GATTCCCAGCGGTGATCT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10148187"/>
                  </a:ext>
                </a:extLst>
              </a:tr>
              <a:tr h="368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DNAJC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AGGAAAGGCTGCTTTGGAA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CCAGCAGGGAACAGATTCA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062808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104193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2 Subtítulo">
            <a:extLst>
              <a:ext uri="{FF2B5EF4-FFF2-40B4-BE49-F238E27FC236}">
                <a16:creationId xmlns:a16="http://schemas.microsoft.com/office/drawing/2014/main" id="{4FA2C513-BCA5-4EA1-BD67-579228D87EF4}"/>
              </a:ext>
            </a:extLst>
          </p:cNvPr>
          <p:cNvSpPr txBox="1">
            <a:spLocks/>
          </p:cNvSpPr>
          <p:nvPr/>
        </p:nvSpPr>
        <p:spPr>
          <a:xfrm>
            <a:off x="1259632" y="5877272"/>
            <a:ext cx="6400800" cy="648072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dirty="0" err="1"/>
              <a:t>Supp</a:t>
            </a:r>
            <a:r>
              <a:rPr lang="es-ES"/>
              <a:t>. Table 3</a:t>
            </a:r>
          </a:p>
        </p:txBody>
      </p:sp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id="{749ED1BD-5DD1-46A2-8E40-9777B39809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2050793"/>
              </p:ext>
            </p:extLst>
          </p:nvPr>
        </p:nvGraphicFramePr>
        <p:xfrm>
          <a:off x="2771800" y="692696"/>
          <a:ext cx="3069248" cy="4620915"/>
        </p:xfrm>
        <a:graphic>
          <a:graphicData uri="http://schemas.openxmlformats.org/drawingml/2006/table">
            <a:tbl>
              <a:tblPr/>
              <a:tblGrid>
                <a:gridCol w="781348">
                  <a:extLst>
                    <a:ext uri="{9D8B030D-6E8A-4147-A177-3AD203B41FA5}">
                      <a16:colId xmlns:a16="http://schemas.microsoft.com/office/drawing/2014/main" val="2136065798"/>
                    </a:ext>
                  </a:extLst>
                </a:gridCol>
                <a:gridCol w="653438">
                  <a:extLst>
                    <a:ext uri="{9D8B030D-6E8A-4147-A177-3AD203B41FA5}">
                      <a16:colId xmlns:a16="http://schemas.microsoft.com/office/drawing/2014/main" val="3755365072"/>
                    </a:ext>
                  </a:extLst>
                </a:gridCol>
                <a:gridCol w="548679">
                  <a:extLst>
                    <a:ext uri="{9D8B030D-6E8A-4147-A177-3AD203B41FA5}">
                      <a16:colId xmlns:a16="http://schemas.microsoft.com/office/drawing/2014/main" val="1641391961"/>
                    </a:ext>
                  </a:extLst>
                </a:gridCol>
                <a:gridCol w="548679">
                  <a:extLst>
                    <a:ext uri="{9D8B030D-6E8A-4147-A177-3AD203B41FA5}">
                      <a16:colId xmlns:a16="http://schemas.microsoft.com/office/drawing/2014/main" val="2177821562"/>
                    </a:ext>
                  </a:extLst>
                </a:gridCol>
                <a:gridCol w="537104">
                  <a:extLst>
                    <a:ext uri="{9D8B030D-6E8A-4147-A177-3AD203B41FA5}">
                      <a16:colId xmlns:a16="http://schemas.microsoft.com/office/drawing/2014/main" val="1432937333"/>
                    </a:ext>
                  </a:extLst>
                </a:gridCol>
              </a:tblGrid>
              <a:tr h="167628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dition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DR (%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6217220"/>
                  </a:ext>
                </a:extLst>
              </a:tr>
              <a:tr h="167628"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h&amp;24h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OXB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,3E-0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0433757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IP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6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5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0218864"/>
                  </a:ext>
                </a:extLst>
              </a:tr>
              <a:tr h="167628">
                <a:tc rowSpan="9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h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IS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6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,9E-0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3133429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P13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9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3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297049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ZBTB3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1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7505051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MARCB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5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2035327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LF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6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1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8654299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XN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8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7088724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TA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6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2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457874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BX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6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3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4216218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RB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7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4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8693758"/>
                  </a:ext>
                </a:extLst>
              </a:tr>
              <a:tr h="167628">
                <a:tc rowSpan="15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h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ERG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3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0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5351180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ZNF63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4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0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2612656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NAJC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2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02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6830814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COM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4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1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4339445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YBL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2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4021001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UBP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5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1847252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MO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4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7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6298826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2AF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07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0630979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2F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5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8028610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R2F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9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2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3200302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CGF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5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2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6360606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F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6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6309923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K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7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3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4785077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RC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4259514"/>
                  </a:ext>
                </a:extLst>
              </a:tr>
              <a:tr h="167628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NRNPD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5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,04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077" marR="8077" marT="807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99413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7406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3</TotalTime>
  <Words>277</Words>
  <Application>Microsoft Office PowerPoint</Application>
  <PresentationFormat>Presentación en pantalla (4:3)</PresentationFormat>
  <Paragraphs>181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iguel</dc:creator>
  <cp:lastModifiedBy>MARÍA DEL MAR NOBLEJAS LÓPEZ</cp:lastModifiedBy>
  <cp:revision>27</cp:revision>
  <dcterms:created xsi:type="dcterms:W3CDTF">2020-06-24T09:58:52Z</dcterms:created>
  <dcterms:modified xsi:type="dcterms:W3CDTF">2021-02-17T12:00:51Z</dcterms:modified>
</cp:coreProperties>
</file>